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"/>
  </p:notesMasterIdLst>
  <p:sldIdLst>
    <p:sldId id="256" r:id="rId2"/>
    <p:sldId id="261" r:id="rId3"/>
    <p:sldId id="257" r:id="rId4"/>
    <p:sldId id="258" r:id="rId5"/>
    <p:sldId id="259" r:id="rId6"/>
    <p:sldId id="260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74F7207-DB8A-46B2-BAFA-D00F1FAA4C51}" v="2" dt="2024-08-19T18:15:13.15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364"/>
    <p:restoredTop sz="94718"/>
  </p:normalViewPr>
  <p:slideViewPr>
    <p:cSldViewPr snapToGrid="0">
      <p:cViewPr varScale="1">
        <p:scale>
          <a:sx n="108" d="100"/>
          <a:sy n="108" d="100"/>
        </p:scale>
        <p:origin x="57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Relationship Id="rId14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oetzman, Eric S" userId="ca007215-aa63-480c-aae6-3dab720b7209" providerId="ADAL" clId="{274F7207-DB8A-46B2-BAFA-D00F1FAA4C51}"/>
    <pc:docChg chg="modSld">
      <pc:chgData name="Goetzman, Eric S" userId="ca007215-aa63-480c-aae6-3dab720b7209" providerId="ADAL" clId="{274F7207-DB8A-46B2-BAFA-D00F1FAA4C51}" dt="2024-08-19T18:15:27.131" v="39" actId="14100"/>
      <pc:docMkLst>
        <pc:docMk/>
      </pc:docMkLst>
      <pc:sldChg chg="addSp modSp mod">
        <pc:chgData name="Goetzman, Eric S" userId="ca007215-aa63-480c-aae6-3dab720b7209" providerId="ADAL" clId="{274F7207-DB8A-46B2-BAFA-D00F1FAA4C51}" dt="2024-08-19T18:15:27.131" v="39" actId="14100"/>
        <pc:sldMkLst>
          <pc:docMk/>
          <pc:sldMk cId="2922965917" sldId="261"/>
        </pc:sldMkLst>
        <pc:spChg chg="add mod">
          <ac:chgData name="Goetzman, Eric S" userId="ca007215-aa63-480c-aae6-3dab720b7209" providerId="ADAL" clId="{274F7207-DB8A-46B2-BAFA-D00F1FAA4C51}" dt="2024-08-19T18:15:08.636" v="35" actId="20577"/>
          <ac:spMkLst>
            <pc:docMk/>
            <pc:sldMk cId="2922965917" sldId="261"/>
            <ac:spMk id="5" creationId="{63999750-77FC-F27B-07BC-5E13E671CE09}"/>
          </ac:spMkLst>
        </pc:spChg>
        <pc:spChg chg="add mod">
          <ac:chgData name="Goetzman, Eric S" userId="ca007215-aa63-480c-aae6-3dab720b7209" providerId="ADAL" clId="{274F7207-DB8A-46B2-BAFA-D00F1FAA4C51}" dt="2024-08-19T18:15:27.131" v="39" actId="14100"/>
          <ac:spMkLst>
            <pc:docMk/>
            <pc:sldMk cId="2922965917" sldId="261"/>
            <ac:spMk id="6" creationId="{1BC296D9-DFAC-15B3-C077-DF97364E302A}"/>
          </ac:spMkLst>
        </pc:spChg>
        <pc:spChg chg="mod">
          <ac:chgData name="Goetzman, Eric S" userId="ca007215-aa63-480c-aae6-3dab720b7209" providerId="ADAL" clId="{274F7207-DB8A-46B2-BAFA-D00F1FAA4C51}" dt="2024-08-19T18:14:54.348" v="13" actId="1076"/>
          <ac:spMkLst>
            <pc:docMk/>
            <pc:sldMk cId="2922965917" sldId="261"/>
            <ac:spMk id="8" creationId="{692E5ED4-CD6D-0D8A-FDCA-D009735A97A8}"/>
          </ac:spMkLst>
        </pc:spChg>
        <pc:spChg chg="mod">
          <ac:chgData name="Goetzman, Eric S" userId="ca007215-aa63-480c-aae6-3dab720b7209" providerId="ADAL" clId="{274F7207-DB8A-46B2-BAFA-D00F1FAA4C51}" dt="2024-08-19T18:14:34.621" v="8" actId="1076"/>
          <ac:spMkLst>
            <pc:docMk/>
            <pc:sldMk cId="2922965917" sldId="261"/>
            <ac:spMk id="9" creationId="{59286B91-9262-E287-EA89-162FB87AAD36}"/>
          </ac:spMkLst>
        </pc:spChg>
        <pc:picChg chg="add mod modCrop">
          <ac:chgData name="Goetzman, Eric S" userId="ca007215-aa63-480c-aae6-3dab720b7209" providerId="ADAL" clId="{274F7207-DB8A-46B2-BAFA-D00F1FAA4C51}" dt="2024-08-19T18:14:38.644" v="9" actId="1076"/>
          <ac:picMkLst>
            <pc:docMk/>
            <pc:sldMk cId="2922965917" sldId="261"/>
            <ac:picMk id="3" creationId="{B59F4656-D44B-E1B7-C485-613F23B9F101}"/>
          </ac:picMkLst>
        </pc:picChg>
        <pc:picChg chg="mod">
          <ac:chgData name="Goetzman, Eric S" userId="ca007215-aa63-480c-aae6-3dab720b7209" providerId="ADAL" clId="{274F7207-DB8A-46B2-BAFA-D00F1FAA4C51}" dt="2024-08-19T18:14:34.621" v="8" actId="1076"/>
          <ac:picMkLst>
            <pc:docMk/>
            <pc:sldMk cId="2922965917" sldId="261"/>
            <ac:picMk id="7" creationId="{862BAFD2-85D2-8BE0-B07E-4A96F066AA94}"/>
          </ac:picMkLst>
        </pc:picChg>
      </pc:sldChg>
    </pc:docChg>
  </pc:docChgLst>
  <pc:docChgLst>
    <pc:chgData name="Goetzman, Eric S" userId="ca007215-aa63-480c-aae6-3dab720b7209" providerId="ADAL" clId="{C4BA515E-B975-4632-9A0E-CF979AE74528}"/>
    <pc:docChg chg="undo custSel addSld modSld">
      <pc:chgData name="Goetzman, Eric S" userId="ca007215-aa63-480c-aae6-3dab720b7209" providerId="ADAL" clId="{C4BA515E-B975-4632-9A0E-CF979AE74528}" dt="2024-08-16T01:26:33.289" v="196" actId="14100"/>
      <pc:docMkLst>
        <pc:docMk/>
      </pc:docMkLst>
      <pc:sldChg chg="addSp modSp mod">
        <pc:chgData name="Goetzman, Eric S" userId="ca007215-aa63-480c-aae6-3dab720b7209" providerId="ADAL" clId="{C4BA515E-B975-4632-9A0E-CF979AE74528}" dt="2024-08-16T01:13:03.295" v="45" actId="403"/>
        <pc:sldMkLst>
          <pc:docMk/>
          <pc:sldMk cId="61098732" sldId="256"/>
        </pc:sldMkLst>
        <pc:spChg chg="add mod">
          <ac:chgData name="Goetzman, Eric S" userId="ca007215-aa63-480c-aae6-3dab720b7209" providerId="ADAL" clId="{C4BA515E-B975-4632-9A0E-CF979AE74528}" dt="2024-08-16T01:13:03.295" v="45" actId="403"/>
          <ac:spMkLst>
            <pc:docMk/>
            <pc:sldMk cId="61098732" sldId="256"/>
            <ac:spMk id="2" creationId="{F16E262D-1E62-EFA7-2AA6-E09EFA72B2A2}"/>
          </ac:spMkLst>
        </pc:spChg>
      </pc:sldChg>
      <pc:sldChg chg="addSp modSp mod">
        <pc:chgData name="Goetzman, Eric S" userId="ca007215-aa63-480c-aae6-3dab720b7209" providerId="ADAL" clId="{C4BA515E-B975-4632-9A0E-CF979AE74528}" dt="2024-08-16T01:18:42.317" v="125" actId="113"/>
        <pc:sldMkLst>
          <pc:docMk/>
          <pc:sldMk cId="3616797103" sldId="257"/>
        </pc:sldMkLst>
        <pc:spChg chg="add mod">
          <ac:chgData name="Goetzman, Eric S" userId="ca007215-aa63-480c-aae6-3dab720b7209" providerId="ADAL" clId="{C4BA515E-B975-4632-9A0E-CF979AE74528}" dt="2024-08-16T01:18:42.317" v="125" actId="113"/>
          <ac:spMkLst>
            <pc:docMk/>
            <pc:sldMk cId="3616797103" sldId="257"/>
            <ac:spMk id="2" creationId="{9CCE4F16-06F8-A7B9-2A5B-C6F512F183D3}"/>
          </ac:spMkLst>
        </pc:spChg>
        <pc:spChg chg="mod">
          <ac:chgData name="Goetzman, Eric S" userId="ca007215-aa63-480c-aae6-3dab720b7209" providerId="ADAL" clId="{C4BA515E-B975-4632-9A0E-CF979AE74528}" dt="2024-08-16T01:18:38.443" v="123" actId="1076"/>
          <ac:spMkLst>
            <pc:docMk/>
            <pc:sldMk cId="3616797103" sldId="257"/>
            <ac:spMk id="7" creationId="{0F1550ED-14DD-1B37-FD9E-2E39AE6840D0}"/>
          </ac:spMkLst>
        </pc:spChg>
        <pc:spChg chg="mod">
          <ac:chgData name="Goetzman, Eric S" userId="ca007215-aa63-480c-aae6-3dab720b7209" providerId="ADAL" clId="{C4BA515E-B975-4632-9A0E-CF979AE74528}" dt="2024-08-16T01:18:32.807" v="122" actId="1076"/>
          <ac:spMkLst>
            <pc:docMk/>
            <pc:sldMk cId="3616797103" sldId="257"/>
            <ac:spMk id="8" creationId="{776DBE44-6C96-2AD7-888E-4D65F3D926B2}"/>
          </ac:spMkLst>
        </pc:spChg>
        <pc:spChg chg="mod">
          <ac:chgData name="Goetzman, Eric S" userId="ca007215-aa63-480c-aae6-3dab720b7209" providerId="ADAL" clId="{C4BA515E-B975-4632-9A0E-CF979AE74528}" dt="2024-08-16T01:18:38.443" v="123" actId="1076"/>
          <ac:spMkLst>
            <pc:docMk/>
            <pc:sldMk cId="3616797103" sldId="257"/>
            <ac:spMk id="10" creationId="{44D51788-BF3B-09B9-AAB1-C664645C6BD0}"/>
          </ac:spMkLst>
        </pc:spChg>
        <pc:spChg chg="mod">
          <ac:chgData name="Goetzman, Eric S" userId="ca007215-aa63-480c-aae6-3dab720b7209" providerId="ADAL" clId="{C4BA515E-B975-4632-9A0E-CF979AE74528}" dt="2024-08-16T01:18:38.443" v="123" actId="1076"/>
          <ac:spMkLst>
            <pc:docMk/>
            <pc:sldMk cId="3616797103" sldId="257"/>
            <ac:spMk id="11" creationId="{C3E0F66A-06EB-6E67-E47D-F6F00E130F1D}"/>
          </ac:spMkLst>
        </pc:spChg>
        <pc:spChg chg="mod">
          <ac:chgData name="Goetzman, Eric S" userId="ca007215-aa63-480c-aae6-3dab720b7209" providerId="ADAL" clId="{C4BA515E-B975-4632-9A0E-CF979AE74528}" dt="2024-08-16T01:18:38.443" v="123" actId="1076"/>
          <ac:spMkLst>
            <pc:docMk/>
            <pc:sldMk cId="3616797103" sldId="257"/>
            <ac:spMk id="12" creationId="{3CB4DBC7-95A1-3F5E-E0AE-E752DDB53AD7}"/>
          </ac:spMkLst>
        </pc:spChg>
        <pc:spChg chg="mod">
          <ac:chgData name="Goetzman, Eric S" userId="ca007215-aa63-480c-aae6-3dab720b7209" providerId="ADAL" clId="{C4BA515E-B975-4632-9A0E-CF979AE74528}" dt="2024-08-16T01:18:38.443" v="123" actId="1076"/>
          <ac:spMkLst>
            <pc:docMk/>
            <pc:sldMk cId="3616797103" sldId="257"/>
            <ac:spMk id="13" creationId="{197E8E2E-97E5-A9AC-577E-3B84D93281B4}"/>
          </ac:spMkLst>
        </pc:spChg>
        <pc:spChg chg="mod">
          <ac:chgData name="Goetzman, Eric S" userId="ca007215-aa63-480c-aae6-3dab720b7209" providerId="ADAL" clId="{C4BA515E-B975-4632-9A0E-CF979AE74528}" dt="2024-08-16T01:18:38.443" v="123" actId="1076"/>
          <ac:spMkLst>
            <pc:docMk/>
            <pc:sldMk cId="3616797103" sldId="257"/>
            <ac:spMk id="14" creationId="{9F27CCFF-EDE7-67F5-E616-5432071E55D6}"/>
          </ac:spMkLst>
        </pc:spChg>
        <pc:spChg chg="mod">
          <ac:chgData name="Goetzman, Eric S" userId="ca007215-aa63-480c-aae6-3dab720b7209" providerId="ADAL" clId="{C4BA515E-B975-4632-9A0E-CF979AE74528}" dt="2024-08-16T01:18:38.443" v="123" actId="1076"/>
          <ac:spMkLst>
            <pc:docMk/>
            <pc:sldMk cId="3616797103" sldId="257"/>
            <ac:spMk id="15" creationId="{B60F648D-A4A6-4CAB-124B-350F2C656C54}"/>
          </ac:spMkLst>
        </pc:spChg>
        <pc:spChg chg="mod">
          <ac:chgData name="Goetzman, Eric S" userId="ca007215-aa63-480c-aae6-3dab720b7209" providerId="ADAL" clId="{C4BA515E-B975-4632-9A0E-CF979AE74528}" dt="2024-08-16T01:18:32.807" v="122" actId="1076"/>
          <ac:spMkLst>
            <pc:docMk/>
            <pc:sldMk cId="3616797103" sldId="257"/>
            <ac:spMk id="18" creationId="{78ED9B29-06CA-D1FF-A485-024D8A70B22E}"/>
          </ac:spMkLst>
        </pc:spChg>
        <pc:picChg chg="mod">
          <ac:chgData name="Goetzman, Eric S" userId="ca007215-aa63-480c-aae6-3dab720b7209" providerId="ADAL" clId="{C4BA515E-B975-4632-9A0E-CF979AE74528}" dt="2024-08-16T01:18:38.443" v="123" actId="1076"/>
          <ac:picMkLst>
            <pc:docMk/>
            <pc:sldMk cId="3616797103" sldId="257"/>
            <ac:picMk id="4" creationId="{3A3D4AD3-F7D2-515D-30AE-5EA0D093245B}"/>
          </ac:picMkLst>
        </pc:picChg>
        <pc:picChg chg="mod">
          <ac:chgData name="Goetzman, Eric S" userId="ca007215-aa63-480c-aae6-3dab720b7209" providerId="ADAL" clId="{C4BA515E-B975-4632-9A0E-CF979AE74528}" dt="2024-08-16T01:18:32.807" v="122" actId="1076"/>
          <ac:picMkLst>
            <pc:docMk/>
            <pc:sldMk cId="3616797103" sldId="257"/>
            <ac:picMk id="5" creationId="{304ECBB9-ED5B-32C9-D0F3-49A0D804E8E4}"/>
          </ac:picMkLst>
        </pc:picChg>
      </pc:sldChg>
      <pc:sldChg chg="addSp delSp modSp mod">
        <pc:chgData name="Goetzman, Eric S" userId="ca007215-aa63-480c-aae6-3dab720b7209" providerId="ADAL" clId="{C4BA515E-B975-4632-9A0E-CF979AE74528}" dt="2024-08-16T01:23:53.467" v="177"/>
        <pc:sldMkLst>
          <pc:docMk/>
          <pc:sldMk cId="168444324" sldId="258"/>
        </pc:sldMkLst>
        <pc:spChg chg="add mod">
          <ac:chgData name="Goetzman, Eric S" userId="ca007215-aa63-480c-aae6-3dab720b7209" providerId="ADAL" clId="{C4BA515E-B975-4632-9A0E-CF979AE74528}" dt="2024-08-16T01:20:00.994" v="132" actId="207"/>
          <ac:spMkLst>
            <pc:docMk/>
            <pc:sldMk cId="168444324" sldId="258"/>
            <ac:spMk id="2" creationId="{DCF53F0B-F5AC-1AA9-B8DB-10AF9A479E56}"/>
          </ac:spMkLst>
        </pc:spChg>
        <pc:spChg chg="add mod">
          <ac:chgData name="Goetzman, Eric S" userId="ca007215-aa63-480c-aae6-3dab720b7209" providerId="ADAL" clId="{C4BA515E-B975-4632-9A0E-CF979AE74528}" dt="2024-08-16T01:21:47.865" v="153" actId="1076"/>
          <ac:spMkLst>
            <pc:docMk/>
            <pc:sldMk cId="168444324" sldId="258"/>
            <ac:spMk id="3" creationId="{76009468-DCA8-AAC6-F0A6-500F972108B8}"/>
          </ac:spMkLst>
        </pc:spChg>
        <pc:spChg chg="add mod">
          <ac:chgData name="Goetzman, Eric S" userId="ca007215-aa63-480c-aae6-3dab720b7209" providerId="ADAL" clId="{C4BA515E-B975-4632-9A0E-CF979AE74528}" dt="2024-08-16T01:21:45.324" v="152" actId="1076"/>
          <ac:spMkLst>
            <pc:docMk/>
            <pc:sldMk cId="168444324" sldId="258"/>
            <ac:spMk id="8" creationId="{31AD0950-410D-EFB7-6534-3BAD306B8F9E}"/>
          </ac:spMkLst>
        </pc:spChg>
        <pc:spChg chg="mod">
          <ac:chgData name="Goetzman, Eric S" userId="ca007215-aa63-480c-aae6-3dab720b7209" providerId="ADAL" clId="{C4BA515E-B975-4632-9A0E-CF979AE74528}" dt="2024-08-16T01:21:36.234" v="151" actId="208"/>
          <ac:spMkLst>
            <pc:docMk/>
            <pc:sldMk cId="168444324" sldId="258"/>
            <ac:spMk id="11" creationId="{5826CB02-8054-DD42-9C4E-07037BC570EC}"/>
          </ac:spMkLst>
        </pc:spChg>
        <pc:spChg chg="add del mod">
          <ac:chgData name="Goetzman, Eric S" userId="ca007215-aa63-480c-aae6-3dab720b7209" providerId="ADAL" clId="{C4BA515E-B975-4632-9A0E-CF979AE74528}" dt="2024-08-16T01:23:18.598" v="163" actId="21"/>
          <ac:spMkLst>
            <pc:docMk/>
            <pc:sldMk cId="168444324" sldId="258"/>
            <ac:spMk id="13" creationId="{E60E28AB-F287-71AF-F8E9-C99FD5B0DEB9}"/>
          </ac:spMkLst>
        </pc:spChg>
        <pc:spChg chg="add del mod">
          <ac:chgData name="Goetzman, Eric S" userId="ca007215-aa63-480c-aae6-3dab720b7209" providerId="ADAL" clId="{C4BA515E-B975-4632-9A0E-CF979AE74528}" dt="2024-08-16T01:23:18.598" v="163" actId="21"/>
          <ac:spMkLst>
            <pc:docMk/>
            <pc:sldMk cId="168444324" sldId="258"/>
            <ac:spMk id="15" creationId="{1B9D8BA6-89E1-C094-0CEC-47013251F1AF}"/>
          </ac:spMkLst>
        </pc:spChg>
        <pc:picChg chg="mod">
          <ac:chgData name="Goetzman, Eric S" userId="ca007215-aa63-480c-aae6-3dab720b7209" providerId="ADAL" clId="{C4BA515E-B975-4632-9A0E-CF979AE74528}" dt="2024-08-16T01:23:53.467" v="177"/>
          <ac:picMkLst>
            <pc:docMk/>
            <pc:sldMk cId="168444324" sldId="258"/>
            <ac:picMk id="10" creationId="{D2182F44-620D-DA15-4578-F9680E44B574}"/>
          </ac:picMkLst>
        </pc:picChg>
        <pc:picChg chg="add mod">
          <ac:chgData name="Goetzman, Eric S" userId="ca007215-aa63-480c-aae6-3dab720b7209" providerId="ADAL" clId="{C4BA515E-B975-4632-9A0E-CF979AE74528}" dt="2024-08-16T01:22:17.262" v="156"/>
          <ac:picMkLst>
            <pc:docMk/>
            <pc:sldMk cId="168444324" sldId="258"/>
            <ac:picMk id="14" creationId="{63008EE9-C0F7-17A3-6AF4-4CD0C274D84B}"/>
          </ac:picMkLst>
        </pc:picChg>
      </pc:sldChg>
      <pc:sldChg chg="addSp delSp modSp mod">
        <pc:chgData name="Goetzman, Eric S" userId="ca007215-aa63-480c-aae6-3dab720b7209" providerId="ADAL" clId="{C4BA515E-B975-4632-9A0E-CF979AE74528}" dt="2024-08-16T01:24:42.184" v="178" actId="478"/>
        <pc:sldMkLst>
          <pc:docMk/>
          <pc:sldMk cId="3302000377" sldId="259"/>
        </pc:sldMkLst>
        <pc:spChg chg="del">
          <ac:chgData name="Goetzman, Eric S" userId="ca007215-aa63-480c-aae6-3dab720b7209" providerId="ADAL" clId="{C4BA515E-B975-4632-9A0E-CF979AE74528}" dt="2024-08-16T01:24:42.184" v="178" actId="478"/>
          <ac:spMkLst>
            <pc:docMk/>
            <pc:sldMk cId="3302000377" sldId="259"/>
            <ac:spMk id="5" creationId="{80EB589F-222D-5946-ECE6-A61C5FC10421}"/>
          </ac:spMkLst>
        </pc:spChg>
        <pc:spChg chg="del">
          <ac:chgData name="Goetzman, Eric S" userId="ca007215-aa63-480c-aae6-3dab720b7209" providerId="ADAL" clId="{C4BA515E-B975-4632-9A0E-CF979AE74528}" dt="2024-08-16T01:24:42.184" v="178" actId="478"/>
          <ac:spMkLst>
            <pc:docMk/>
            <pc:sldMk cId="3302000377" sldId="259"/>
            <ac:spMk id="6" creationId="{6C828184-4EAB-4036-B24B-004923EB78FD}"/>
          </ac:spMkLst>
        </pc:spChg>
        <pc:spChg chg="del">
          <ac:chgData name="Goetzman, Eric S" userId="ca007215-aa63-480c-aae6-3dab720b7209" providerId="ADAL" clId="{C4BA515E-B975-4632-9A0E-CF979AE74528}" dt="2024-08-16T01:24:42.184" v="178" actId="478"/>
          <ac:spMkLst>
            <pc:docMk/>
            <pc:sldMk cId="3302000377" sldId="259"/>
            <ac:spMk id="7" creationId="{8143D45D-C3EA-71D7-ADFF-7BB939225C2A}"/>
          </ac:spMkLst>
        </pc:spChg>
        <pc:spChg chg="del">
          <ac:chgData name="Goetzman, Eric S" userId="ca007215-aa63-480c-aae6-3dab720b7209" providerId="ADAL" clId="{C4BA515E-B975-4632-9A0E-CF979AE74528}" dt="2024-08-16T01:24:42.184" v="178" actId="478"/>
          <ac:spMkLst>
            <pc:docMk/>
            <pc:sldMk cId="3302000377" sldId="259"/>
            <ac:spMk id="9" creationId="{1C3C47A4-3BE5-D99D-0D89-1F900498EB80}"/>
          </ac:spMkLst>
        </pc:spChg>
        <pc:spChg chg="del">
          <ac:chgData name="Goetzman, Eric S" userId="ca007215-aa63-480c-aae6-3dab720b7209" providerId="ADAL" clId="{C4BA515E-B975-4632-9A0E-CF979AE74528}" dt="2024-08-16T01:23:09.447" v="162" actId="478"/>
          <ac:spMkLst>
            <pc:docMk/>
            <pc:sldMk cId="3302000377" sldId="259"/>
            <ac:spMk id="11" creationId="{5826CB02-8054-DD42-9C4E-07037BC570EC}"/>
          </ac:spMkLst>
        </pc:spChg>
        <pc:spChg chg="add mod">
          <ac:chgData name="Goetzman, Eric S" userId="ca007215-aa63-480c-aae6-3dab720b7209" providerId="ADAL" clId="{C4BA515E-B975-4632-9A0E-CF979AE74528}" dt="2024-08-16T01:23:29.272" v="174" actId="1036"/>
          <ac:spMkLst>
            <pc:docMk/>
            <pc:sldMk cId="3302000377" sldId="259"/>
            <ac:spMk id="13" creationId="{E60E28AB-F287-71AF-F8E9-C99FD5B0DEB9}"/>
          </ac:spMkLst>
        </pc:spChg>
        <pc:spChg chg="add mod">
          <ac:chgData name="Goetzman, Eric S" userId="ca007215-aa63-480c-aae6-3dab720b7209" providerId="ADAL" clId="{C4BA515E-B975-4632-9A0E-CF979AE74528}" dt="2024-08-16T01:23:29.272" v="174" actId="1036"/>
          <ac:spMkLst>
            <pc:docMk/>
            <pc:sldMk cId="3302000377" sldId="259"/>
            <ac:spMk id="15" creationId="{1B9D8BA6-89E1-C094-0CEC-47013251F1AF}"/>
          </ac:spMkLst>
        </pc:spChg>
        <pc:picChg chg="mod">
          <ac:chgData name="Goetzman, Eric S" userId="ca007215-aa63-480c-aae6-3dab720b7209" providerId="ADAL" clId="{C4BA515E-B975-4632-9A0E-CF979AE74528}" dt="2024-08-16T01:23:43.295" v="176"/>
          <ac:picMkLst>
            <pc:docMk/>
            <pc:sldMk cId="3302000377" sldId="259"/>
            <ac:picMk id="10" creationId="{D2182F44-620D-DA15-4578-F9680E44B574}"/>
          </ac:picMkLst>
        </pc:picChg>
      </pc:sldChg>
      <pc:sldChg chg="addSp delSp modSp mod">
        <pc:chgData name="Goetzman, Eric S" userId="ca007215-aa63-480c-aae6-3dab720b7209" providerId="ADAL" clId="{C4BA515E-B975-4632-9A0E-CF979AE74528}" dt="2024-08-16T01:26:33.289" v="196" actId="14100"/>
        <pc:sldMkLst>
          <pc:docMk/>
          <pc:sldMk cId="3190027684" sldId="260"/>
        </pc:sldMkLst>
        <pc:spChg chg="add mod">
          <ac:chgData name="Goetzman, Eric S" userId="ca007215-aa63-480c-aae6-3dab720b7209" providerId="ADAL" clId="{C4BA515E-B975-4632-9A0E-CF979AE74528}" dt="2024-08-16T01:25:53.913" v="187" actId="14100"/>
          <ac:spMkLst>
            <pc:docMk/>
            <pc:sldMk cId="3190027684" sldId="260"/>
            <ac:spMk id="2" creationId="{70143B54-4F33-5FA2-D70E-4A631CCDF2F7}"/>
          </ac:spMkLst>
        </pc:spChg>
        <pc:spChg chg="add del mod">
          <ac:chgData name="Goetzman, Eric S" userId="ca007215-aa63-480c-aae6-3dab720b7209" providerId="ADAL" clId="{C4BA515E-B975-4632-9A0E-CF979AE74528}" dt="2024-08-16T01:25:32.729" v="182" actId="478"/>
          <ac:spMkLst>
            <pc:docMk/>
            <pc:sldMk cId="3190027684" sldId="260"/>
            <ac:spMk id="3" creationId="{C48B49C9-D263-437D-A715-772C598BC710}"/>
          </ac:spMkLst>
        </pc:spChg>
        <pc:spChg chg="add mod">
          <ac:chgData name="Goetzman, Eric S" userId="ca007215-aa63-480c-aae6-3dab720b7209" providerId="ADAL" clId="{C4BA515E-B975-4632-9A0E-CF979AE74528}" dt="2024-08-16T01:26:16.074" v="193" actId="1076"/>
          <ac:spMkLst>
            <pc:docMk/>
            <pc:sldMk cId="3190027684" sldId="260"/>
            <ac:spMk id="8" creationId="{40914D9B-6535-A110-992E-6FA038BB69E3}"/>
          </ac:spMkLst>
        </pc:spChg>
        <pc:spChg chg="add mod">
          <ac:chgData name="Goetzman, Eric S" userId="ca007215-aa63-480c-aae6-3dab720b7209" providerId="ADAL" clId="{C4BA515E-B975-4632-9A0E-CF979AE74528}" dt="2024-08-16T01:26:33.289" v="196" actId="14100"/>
          <ac:spMkLst>
            <pc:docMk/>
            <pc:sldMk cId="3190027684" sldId="260"/>
            <ac:spMk id="12" creationId="{D7853CC0-F531-9E0D-45A4-A907C9DA9B6A}"/>
          </ac:spMkLst>
        </pc:spChg>
        <pc:picChg chg="mod">
          <ac:chgData name="Goetzman, Eric S" userId="ca007215-aa63-480c-aae6-3dab720b7209" providerId="ADAL" clId="{C4BA515E-B975-4632-9A0E-CF979AE74528}" dt="2024-08-16T01:26:07.122" v="192" actId="1076"/>
          <ac:picMkLst>
            <pc:docMk/>
            <pc:sldMk cId="3190027684" sldId="260"/>
            <ac:picMk id="4" creationId="{1F148F2E-6805-88D4-3E4A-BC65072DFF73}"/>
          </ac:picMkLst>
        </pc:picChg>
        <pc:picChg chg="mod">
          <ac:chgData name="Goetzman, Eric S" userId="ca007215-aa63-480c-aae6-3dab720b7209" providerId="ADAL" clId="{C4BA515E-B975-4632-9A0E-CF979AE74528}" dt="2024-08-16T01:25:20.159" v="179" actId="688"/>
          <ac:picMkLst>
            <pc:docMk/>
            <pc:sldMk cId="3190027684" sldId="260"/>
            <ac:picMk id="9" creationId="{A36F10F3-A254-DC5D-217D-77C516E3BC67}"/>
          </ac:picMkLst>
        </pc:picChg>
      </pc:sldChg>
      <pc:sldChg chg="addSp delSp modSp new mod">
        <pc:chgData name="Goetzman, Eric S" userId="ca007215-aa63-480c-aae6-3dab720b7209" providerId="ADAL" clId="{C4BA515E-B975-4632-9A0E-CF979AE74528}" dt="2024-08-16T01:17:15.846" v="109" actId="207"/>
        <pc:sldMkLst>
          <pc:docMk/>
          <pc:sldMk cId="2922965917" sldId="261"/>
        </pc:sldMkLst>
        <pc:spChg chg="del">
          <ac:chgData name="Goetzman, Eric S" userId="ca007215-aa63-480c-aae6-3dab720b7209" providerId="ADAL" clId="{C4BA515E-B975-4632-9A0E-CF979AE74528}" dt="2024-08-16T01:14:50.425" v="48" actId="478"/>
          <ac:spMkLst>
            <pc:docMk/>
            <pc:sldMk cId="2922965917" sldId="261"/>
            <ac:spMk id="2" creationId="{E81A4057-8D60-E4C1-DF01-3978B746D0F4}"/>
          </ac:spMkLst>
        </pc:spChg>
        <pc:spChg chg="del">
          <ac:chgData name="Goetzman, Eric S" userId="ca007215-aa63-480c-aae6-3dab720b7209" providerId="ADAL" clId="{C4BA515E-B975-4632-9A0E-CF979AE74528}" dt="2024-08-16T01:14:49.556" v="47" actId="478"/>
          <ac:spMkLst>
            <pc:docMk/>
            <pc:sldMk cId="2922965917" sldId="261"/>
            <ac:spMk id="3" creationId="{1604AE60-B1FC-010C-843D-DDF262C54E33}"/>
          </ac:spMkLst>
        </pc:spChg>
        <pc:spChg chg="add mod">
          <ac:chgData name="Goetzman, Eric S" userId="ca007215-aa63-480c-aae6-3dab720b7209" providerId="ADAL" clId="{C4BA515E-B975-4632-9A0E-CF979AE74528}" dt="2024-08-16T01:17:02.065" v="106" actId="20577"/>
          <ac:spMkLst>
            <pc:docMk/>
            <pc:sldMk cId="2922965917" sldId="261"/>
            <ac:spMk id="8" creationId="{692E5ED4-CD6D-0D8A-FDCA-D009735A97A8}"/>
          </ac:spMkLst>
        </pc:spChg>
        <pc:spChg chg="add mod">
          <ac:chgData name="Goetzman, Eric S" userId="ca007215-aa63-480c-aae6-3dab720b7209" providerId="ADAL" clId="{C4BA515E-B975-4632-9A0E-CF979AE74528}" dt="2024-08-16T01:17:15.846" v="109" actId="207"/>
          <ac:spMkLst>
            <pc:docMk/>
            <pc:sldMk cId="2922965917" sldId="261"/>
            <ac:spMk id="9" creationId="{59286B91-9262-E287-EA89-162FB87AAD36}"/>
          </ac:spMkLst>
        </pc:spChg>
        <pc:picChg chg="add del mod">
          <ac:chgData name="Goetzman, Eric S" userId="ca007215-aa63-480c-aae6-3dab720b7209" providerId="ADAL" clId="{C4BA515E-B975-4632-9A0E-CF979AE74528}" dt="2024-08-16T01:15:27.232" v="52" actId="478"/>
          <ac:picMkLst>
            <pc:docMk/>
            <pc:sldMk cId="2922965917" sldId="261"/>
            <ac:picMk id="5" creationId="{B582F0DF-910F-D12B-EC41-C980ABD8E0AF}"/>
          </ac:picMkLst>
        </pc:picChg>
        <pc:picChg chg="add mod modCrop">
          <ac:chgData name="Goetzman, Eric S" userId="ca007215-aa63-480c-aae6-3dab720b7209" providerId="ADAL" clId="{C4BA515E-B975-4632-9A0E-CF979AE74528}" dt="2024-08-16T01:16:29.479" v="61"/>
          <ac:picMkLst>
            <pc:docMk/>
            <pc:sldMk cId="2922965917" sldId="261"/>
            <ac:picMk id="7" creationId="{862BAFD2-85D2-8BE0-B07E-4A96F066AA94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62CAB1-E7AF-A849-87B9-FCDE1C4FA883}" type="datetimeFigureOut">
              <a:rPr lang="en-US" smtClean="0"/>
              <a:t>8/19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FB05D0-AFDD-A64D-A46A-0C3AF30161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2336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 1f. Sirt2 in Sirt2+/+ male vs Sirt2+/+ female liver lysate with actin control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CFB05D0-AFDD-A64D-A46A-0C3AF301619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735873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2d. Cytosol and nuclear compartmentalization; anti-Sirt2, anti-tubulin, and anti-Lamin A/C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CFB05D0-AFDD-A64D-A46A-0C3AF3016191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876700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2e. Mitochondria fraction vs positive control (Sirt2+/+ tissue lysate) and negative control (Sirt2-/- tissue lysate); anti-Sirt2 and ponceau loading control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CFB05D0-AFDD-A64D-A46A-0C3AF3016191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630233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2f. Peroxisome fraction vs positive control (Sirt2+/+ tissue lysate) and negative control (Sirt2-/- tissue lysate); anti-Sirt2 and ponceau loading control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CFB05D0-AFDD-A64D-A46A-0C3AF3016191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808225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2g. Mito vs peroxisome fraction preparation in Sirt2-/- vs Sirt2+/+ tissue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CFB05D0-AFDD-A64D-A46A-0C3AF3016191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42235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1D9418-3130-53DC-90B7-086560D2A65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85C4D29-DBED-FF15-021B-37174FE50CC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DDCF4F-06EB-1B43-7EC8-0C89C4A4F4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761CB-C784-A84F-9641-FB2295F1F1A2}" type="datetimeFigureOut">
              <a:rPr lang="en-US" smtClean="0"/>
              <a:t>8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745703-6F33-81F2-5144-5FCD8C75F8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9D92F8-678F-23A9-530C-228A5E2EC5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022E1C-EB61-594C-AB5E-CD1E988802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03542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220A51-9137-8CEC-51EF-707DDE28F3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9B8DCBC-76DD-B973-7972-C5510726E25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0B0402-661B-F2AF-0C6F-558BEA2E85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761CB-C784-A84F-9641-FB2295F1F1A2}" type="datetimeFigureOut">
              <a:rPr lang="en-US" smtClean="0"/>
              <a:t>8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E9F385-C40D-D459-748E-B8D4FA5A81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E12EC4-A3C5-E452-A88A-17F166CE53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022E1C-EB61-594C-AB5E-CD1E988802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57592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64E572D-A3C5-EF54-7587-12A35D2C7BC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A461FB7-5998-7B3C-5B6C-AE186CB444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25936B-ADAF-E23E-5D1B-6E0659F241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761CB-C784-A84F-9641-FB2295F1F1A2}" type="datetimeFigureOut">
              <a:rPr lang="en-US" smtClean="0"/>
              <a:t>8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43D708-CCF7-B333-21EB-16015B5044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66B4F3-398E-C66A-0B0B-AE6B933DF2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022E1C-EB61-594C-AB5E-CD1E988802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68619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AC5139-1B8B-5A83-9947-B1A13B3956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8DB8C7C-D36B-1239-6B0C-9333FB1EA19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B86D29-E947-9E9A-254E-133031C25C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761CB-C784-A84F-9641-FB2295F1F1A2}" type="datetimeFigureOut">
              <a:rPr lang="en-US" smtClean="0"/>
              <a:t>8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E84E32-EC0A-FAD6-B714-9CA7550A1E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2DA2E6C-7EB7-4CE7-D1D4-F41D8BDD1B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022E1C-EB61-594C-AB5E-CD1E988802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85227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7752C0-B585-11BA-731F-C73AB52A59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B669641-40B1-04DE-6C0C-AD8CB2B64F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4B4DE1-5FE8-83A2-6DCA-93F34820A5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761CB-C784-A84F-9641-FB2295F1F1A2}" type="datetimeFigureOut">
              <a:rPr lang="en-US" smtClean="0"/>
              <a:t>8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EEDEDE-642F-966B-534C-557A94F9A0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31F0C8-AC4C-34A8-F8BF-12A312C640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022E1C-EB61-594C-AB5E-CD1E988802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44959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E5E046-3CA6-B3D5-B7ED-2F687F46E7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E0413FD-2B98-2007-6836-58B26071993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09CCA2F-BA8A-AAA6-3426-9C33891057D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5707C8F-6970-5774-96D7-D4607C0FFA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761CB-C784-A84F-9641-FB2295F1F1A2}" type="datetimeFigureOut">
              <a:rPr lang="en-US" smtClean="0"/>
              <a:t>8/1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26CA1F9-0875-3B5B-6583-1C3A6DB78D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8A52B9A-B2BB-A358-4A0C-94BBEA62B3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022E1C-EB61-594C-AB5E-CD1E988802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00627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088728-E054-7384-ED8C-78841CDD14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1B6B192-76A4-21C4-5CC6-C3DFDEA574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6C79FA4-F8D2-5E14-1F24-094CCC0208F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A562CD6-22C9-23E9-C185-E2733DB732D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E6A1F65-4E70-9D50-692A-59027482DB7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57D6C37-0C72-E855-24EF-DAAE1ECF35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761CB-C784-A84F-9641-FB2295F1F1A2}" type="datetimeFigureOut">
              <a:rPr lang="en-US" smtClean="0"/>
              <a:t>8/19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31AF4D4-A56C-6DB3-AF22-462D04FA59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0FF954E-ADE0-A9EA-9D4D-CF8EE3806D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022E1C-EB61-594C-AB5E-CD1E988802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58283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982FBE-F2F8-C30B-F4AF-CDE7CC5E53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C208779-0FAA-AAB4-AA84-F6F79A8B68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761CB-C784-A84F-9641-FB2295F1F1A2}" type="datetimeFigureOut">
              <a:rPr lang="en-US" smtClean="0"/>
              <a:t>8/19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46923FD-51E7-9A4E-E819-C91A647FB8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D3319A8-F3A3-34BE-89C1-EF03D5492E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022E1C-EB61-594C-AB5E-CD1E988802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6941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9B6D1E8-72FD-7C7C-4AF8-06CF1B13FD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761CB-C784-A84F-9641-FB2295F1F1A2}" type="datetimeFigureOut">
              <a:rPr lang="en-US" smtClean="0"/>
              <a:t>8/19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4180177-0F4D-BB04-44C9-2644FCAD95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BF83573-66B3-9B54-AAAB-220821CC62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022E1C-EB61-594C-AB5E-CD1E988802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92315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43FE54-F353-B246-2A02-117F62245A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246738D-0711-158C-96FD-53A982ACEBF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85EEE5E-44B6-6FA7-3524-CD35A903E42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C503E2A-B1E4-4A28-0AB7-2C81D28D5C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761CB-C784-A84F-9641-FB2295F1F1A2}" type="datetimeFigureOut">
              <a:rPr lang="en-US" smtClean="0"/>
              <a:t>8/1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AA2E6A2-0219-C97E-054A-67DE1E435D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3A44EA5-DDB6-D8BA-2654-510B0B7B00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022E1C-EB61-594C-AB5E-CD1E988802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86154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7379FD-D159-5193-6574-C53559B7AD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2A6C3F0-DF60-46CC-EBC7-4EC6C6975D3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7B159B3-D03C-B556-99C1-7DDB55E80BC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915EE92-2306-54EA-B2DE-93D7BC4A6A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761CB-C784-A84F-9641-FB2295F1F1A2}" type="datetimeFigureOut">
              <a:rPr lang="en-US" smtClean="0"/>
              <a:t>8/1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5A6D687-E3B6-046A-D447-4C10FC0318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BDB660E-E509-022D-E387-6543D902E5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022E1C-EB61-594C-AB5E-CD1E988802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55610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4F4FFD2-A195-2589-2D5E-F257E7E439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9B58C85-263D-5ECB-63AF-4BA778CEFE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C70037-C20F-4401-DA73-7FA2BC19351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89761CB-C784-A84F-9641-FB2295F1F1A2}" type="datetimeFigureOut">
              <a:rPr lang="en-US" smtClean="0"/>
              <a:t>8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1CEB27-427E-9B93-19C7-FEC2B996FDD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A350C7-B4B6-C453-C066-03B187E8B23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D022E1C-EB61-594C-AB5E-CD1E988802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58833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5" Type="http://schemas.microsoft.com/office/2007/relationships/hdphoto" Target="../media/hdphoto2.wdp"/><Relationship Id="rId4" Type="http://schemas.openxmlformats.org/officeDocument/2006/relationships/image" Target="../media/image7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4" Type="http://schemas.microsoft.com/office/2007/relationships/hdphoto" Target="../media/hdphoto2.wdp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16E262D-1E62-EFA7-2AA6-E09EFA72B2A2}"/>
              </a:ext>
            </a:extLst>
          </p:cNvPr>
          <p:cNvSpPr txBox="1"/>
          <p:nvPr/>
        </p:nvSpPr>
        <p:spPr>
          <a:xfrm>
            <a:off x="4101882" y="2780021"/>
            <a:ext cx="3735767" cy="8002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800" dirty="0"/>
              <a:t>Uncropped Gel Images</a:t>
            </a:r>
          </a:p>
          <a:p>
            <a:pPr algn="ctr"/>
            <a:r>
              <a:rPr lang="en-US" dirty="0"/>
              <a:t>Schmidt et al</a:t>
            </a:r>
          </a:p>
        </p:txBody>
      </p:sp>
    </p:spTree>
    <p:extLst>
      <p:ext uri="{BB962C8B-B14F-4D97-AF65-F5344CB8AC3E}">
        <p14:creationId xmlns:p14="http://schemas.microsoft.com/office/powerpoint/2010/main" val="610987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862BAFD2-85D2-8BE0-B07E-4A96F066AA9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rcRect l="33146" t="45237" r="21005" b="16098"/>
          <a:stretch/>
        </p:blipFill>
        <p:spPr>
          <a:xfrm rot="-120000">
            <a:off x="4136263" y="791807"/>
            <a:ext cx="3629031" cy="2305477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692E5ED4-CD6D-0D8A-FDCA-D009735A97A8}"/>
              </a:ext>
            </a:extLst>
          </p:cNvPr>
          <p:cNvSpPr txBox="1"/>
          <p:nvPr/>
        </p:nvSpPr>
        <p:spPr>
          <a:xfrm>
            <a:off x="1608042" y="559551"/>
            <a:ext cx="275539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1f.</a:t>
            </a:r>
          </a:p>
          <a:p>
            <a:endParaRPr lang="en-US" dirty="0"/>
          </a:p>
          <a:p>
            <a:r>
              <a:rPr lang="en-US" dirty="0"/>
              <a:t>Anti-Sirt2 immunoblot.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59286B91-9262-E287-EA89-162FB87AAD36}"/>
              </a:ext>
            </a:extLst>
          </p:cNvPr>
          <p:cNvSpPr/>
          <p:nvPr/>
        </p:nvSpPr>
        <p:spPr>
          <a:xfrm>
            <a:off x="4680664" y="1858155"/>
            <a:ext cx="3035808" cy="47548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" name="Picture 2" descr="A close up of a test tube&#10;&#10;Description automatically generated">
            <a:extLst>
              <a:ext uri="{FF2B5EF4-FFF2-40B4-BE49-F238E27FC236}">
                <a16:creationId xmlns:a16="http://schemas.microsoft.com/office/drawing/2014/main" id="{B59F4656-D44B-E1B7-C485-613F23B9F10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0410" t="46882" r="22753" b="23237"/>
          <a:stretch/>
        </p:blipFill>
        <p:spPr>
          <a:xfrm>
            <a:off x="4242359" y="3159908"/>
            <a:ext cx="3707281" cy="178169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63999750-77FC-F27B-07BC-5E13E671CE09}"/>
              </a:ext>
            </a:extLst>
          </p:cNvPr>
          <p:cNvSpPr txBox="1"/>
          <p:nvPr/>
        </p:nvSpPr>
        <p:spPr>
          <a:xfrm>
            <a:off x="1659587" y="3939011"/>
            <a:ext cx="251016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Anti-Actin loading control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1BC296D9-DFAC-15B3-C077-DF97364E302A}"/>
              </a:ext>
            </a:extLst>
          </p:cNvPr>
          <p:cNvSpPr/>
          <p:nvPr/>
        </p:nvSpPr>
        <p:spPr>
          <a:xfrm>
            <a:off x="4680664" y="4010669"/>
            <a:ext cx="3123755" cy="4038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296591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picture containing field, snow, plane, standing&#10;&#10;Description automatically generated">
            <a:extLst>
              <a:ext uri="{FF2B5EF4-FFF2-40B4-BE49-F238E27FC236}">
                <a16:creationId xmlns:a16="http://schemas.microsoft.com/office/drawing/2014/main" id="{3A3D4AD3-F7D2-515D-30AE-5EA0D093245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72" t="21698" r="2379" b="13633"/>
          <a:stretch/>
        </p:blipFill>
        <p:spPr>
          <a:xfrm>
            <a:off x="992179" y="1069464"/>
            <a:ext cx="5952669" cy="2554854"/>
          </a:xfrm>
          <a:prstGeom prst="rect">
            <a:avLst/>
          </a:prstGeom>
        </p:spPr>
      </p:pic>
      <p:pic>
        <p:nvPicPr>
          <p:cNvPr id="5" name="Picture 4" descr="A picture containing game, water, person, guitar&#10;&#10;Description automatically generated">
            <a:extLst>
              <a:ext uri="{FF2B5EF4-FFF2-40B4-BE49-F238E27FC236}">
                <a16:creationId xmlns:a16="http://schemas.microsoft.com/office/drawing/2014/main" id="{304ECBB9-ED5B-32C9-D0F3-49A0D804E8E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957" t="35687" r="-1003" b="1716"/>
          <a:stretch/>
        </p:blipFill>
        <p:spPr>
          <a:xfrm>
            <a:off x="1228812" y="3795768"/>
            <a:ext cx="5581193" cy="2883876"/>
          </a:xfrm>
          <a:prstGeom prst="rect">
            <a:avLst/>
          </a:prstGeom>
        </p:spPr>
      </p:pic>
      <p:pic>
        <p:nvPicPr>
          <p:cNvPr id="6" name="Picture 4" descr="A picture containing white&#10;&#10;Description automatically generated">
            <a:extLst>
              <a:ext uri="{FF2B5EF4-FFF2-40B4-BE49-F238E27FC236}">
                <a16:creationId xmlns:a16="http://schemas.microsoft.com/office/drawing/2014/main" id="{09A7691B-DA59-6CFB-5124-2B5776C440EE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-8388" t="-1926" r="-4719" b="403"/>
          <a:stretch/>
        </p:blipFill>
        <p:spPr>
          <a:xfrm>
            <a:off x="7747415" y="1083169"/>
            <a:ext cx="3733375" cy="3176477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0F1550ED-14DD-1B37-FD9E-2E39AE6840D0}"/>
              </a:ext>
            </a:extLst>
          </p:cNvPr>
          <p:cNvSpPr txBox="1"/>
          <p:nvPr/>
        </p:nvSpPr>
        <p:spPr>
          <a:xfrm>
            <a:off x="1152113" y="626141"/>
            <a:ext cx="12001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nti-Sirt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76DBE44-6C96-2AD7-888E-4D65F3D926B2}"/>
              </a:ext>
            </a:extLst>
          </p:cNvPr>
          <p:cNvSpPr txBox="1"/>
          <p:nvPr/>
        </p:nvSpPr>
        <p:spPr>
          <a:xfrm>
            <a:off x="1257301" y="3584008"/>
            <a:ext cx="1463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nti-tubuli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8F51F08-265E-6D50-696D-F3D79645D903}"/>
              </a:ext>
            </a:extLst>
          </p:cNvPr>
          <p:cNvSpPr txBox="1"/>
          <p:nvPr/>
        </p:nvSpPr>
        <p:spPr>
          <a:xfrm>
            <a:off x="8209938" y="615489"/>
            <a:ext cx="1837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nti-Lamin A/C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4D51788-BF3B-09B9-AAB1-C664645C6BD0}"/>
              </a:ext>
            </a:extLst>
          </p:cNvPr>
          <p:cNvSpPr txBox="1"/>
          <p:nvPr/>
        </p:nvSpPr>
        <p:spPr>
          <a:xfrm rot="18033534">
            <a:off x="1883633" y="1086360"/>
            <a:ext cx="10492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/>
              <a:t>Sirt2+/+ </a:t>
            </a:r>
            <a:r>
              <a:rPr lang="en-US" sz="1200" dirty="0" err="1"/>
              <a:t>Cyto</a:t>
            </a:r>
            <a:endParaRPr lang="en-US" sz="12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3E0F66A-06EB-6E67-E47D-F6F00E130F1D}"/>
              </a:ext>
            </a:extLst>
          </p:cNvPr>
          <p:cNvSpPr txBox="1"/>
          <p:nvPr/>
        </p:nvSpPr>
        <p:spPr>
          <a:xfrm rot="18033534">
            <a:off x="2919720" y="1000215"/>
            <a:ext cx="10492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/>
              <a:t>Sirt2+/+ </a:t>
            </a:r>
            <a:r>
              <a:rPr lang="en-US" sz="1200" dirty="0" err="1"/>
              <a:t>Cyto</a:t>
            </a:r>
            <a:endParaRPr lang="en-US" sz="12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CB4DBC7-95A1-3F5E-E0AE-E752DDB53AD7}"/>
              </a:ext>
            </a:extLst>
          </p:cNvPr>
          <p:cNvSpPr txBox="1"/>
          <p:nvPr/>
        </p:nvSpPr>
        <p:spPr>
          <a:xfrm rot="18033534">
            <a:off x="2574117" y="893970"/>
            <a:ext cx="10492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/>
              <a:t>Sirt2+/+ </a:t>
            </a:r>
            <a:r>
              <a:rPr lang="en-US" sz="1200" dirty="0" err="1"/>
              <a:t>Nuc</a:t>
            </a:r>
            <a:endParaRPr lang="en-US" sz="12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97E8E2E-97E5-A9AC-577E-3B84D93281B4}"/>
              </a:ext>
            </a:extLst>
          </p:cNvPr>
          <p:cNvSpPr txBox="1"/>
          <p:nvPr/>
        </p:nvSpPr>
        <p:spPr>
          <a:xfrm rot="18033534">
            <a:off x="3563124" y="930964"/>
            <a:ext cx="10492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/>
              <a:t>Sirt2+/+ </a:t>
            </a:r>
            <a:r>
              <a:rPr lang="en-US" sz="1200" dirty="0" err="1"/>
              <a:t>Nuc</a:t>
            </a:r>
            <a:endParaRPr lang="en-US" sz="12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F27CCFF-EDE7-67F5-E616-5432071E55D6}"/>
              </a:ext>
            </a:extLst>
          </p:cNvPr>
          <p:cNvSpPr txBox="1"/>
          <p:nvPr/>
        </p:nvSpPr>
        <p:spPr>
          <a:xfrm>
            <a:off x="4552129" y="995364"/>
            <a:ext cx="116055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/>
              <a:t>Sirt2+/+ </a:t>
            </a:r>
            <a:r>
              <a:rPr lang="en-US" sz="1200" dirty="0"/>
              <a:t>homogenat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60F648D-A4A6-4CAB-124B-350F2C656C54}"/>
              </a:ext>
            </a:extLst>
          </p:cNvPr>
          <p:cNvSpPr txBox="1"/>
          <p:nvPr/>
        </p:nvSpPr>
        <p:spPr>
          <a:xfrm>
            <a:off x="5682440" y="1047655"/>
            <a:ext cx="116055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/>
              <a:t>Sirt2-/- </a:t>
            </a:r>
            <a:r>
              <a:rPr lang="en-US" sz="1200" dirty="0"/>
              <a:t>homogenate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7760827-8B50-1128-5ED8-81B431A9CCFE}"/>
              </a:ext>
            </a:extLst>
          </p:cNvPr>
          <p:cNvSpPr txBox="1"/>
          <p:nvPr/>
        </p:nvSpPr>
        <p:spPr>
          <a:xfrm>
            <a:off x="8688208" y="1037003"/>
            <a:ext cx="10492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/>
              <a:t>Sirt2+/+ </a:t>
            </a:r>
            <a:r>
              <a:rPr lang="en-US" sz="1200" dirty="0" err="1"/>
              <a:t>Cyto</a:t>
            </a:r>
            <a:endParaRPr lang="en-US" sz="1200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E1F09E7-E0DD-5D6A-E457-F031829FB6B2}"/>
              </a:ext>
            </a:extLst>
          </p:cNvPr>
          <p:cNvSpPr txBox="1"/>
          <p:nvPr/>
        </p:nvSpPr>
        <p:spPr>
          <a:xfrm>
            <a:off x="9996278" y="1029541"/>
            <a:ext cx="10492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/>
              <a:t>Sirt2+/+ </a:t>
            </a:r>
            <a:r>
              <a:rPr lang="en-US" sz="1200" dirty="0" err="1"/>
              <a:t>Nuc</a:t>
            </a:r>
            <a:endParaRPr lang="en-US" sz="12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8ED9B29-06CA-D1FF-A485-024D8A70B22E}"/>
              </a:ext>
            </a:extLst>
          </p:cNvPr>
          <p:cNvSpPr txBox="1"/>
          <p:nvPr/>
        </p:nvSpPr>
        <p:spPr>
          <a:xfrm>
            <a:off x="1486332" y="6509372"/>
            <a:ext cx="50802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*Stripped, re-probed, and exposed from original (above)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CCE4F16-06F8-A7B9-2A5B-C6F512F183D3}"/>
              </a:ext>
            </a:extLst>
          </p:cNvPr>
          <p:cNvSpPr txBox="1"/>
          <p:nvPr/>
        </p:nvSpPr>
        <p:spPr>
          <a:xfrm>
            <a:off x="88948" y="35093"/>
            <a:ext cx="11843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2 d</a:t>
            </a:r>
          </a:p>
        </p:txBody>
      </p:sp>
    </p:spTree>
    <p:extLst>
      <p:ext uri="{BB962C8B-B14F-4D97-AF65-F5344CB8AC3E}">
        <p14:creationId xmlns:p14="http://schemas.microsoft.com/office/powerpoint/2010/main" val="36167971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picture containing jack&#10;&#10;Description automatically generated">
            <a:extLst>
              <a:ext uri="{FF2B5EF4-FFF2-40B4-BE49-F238E27FC236}">
                <a16:creationId xmlns:a16="http://schemas.microsoft.com/office/drawing/2014/main" id="{178DB29B-EAE2-08B9-56D6-38022AACF77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788" t="24188" r="35980" b="21292"/>
          <a:stretch/>
        </p:blipFill>
        <p:spPr>
          <a:xfrm>
            <a:off x="790406" y="1823598"/>
            <a:ext cx="3067291" cy="321080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80EB589F-222D-5946-ECE6-A61C5FC10421}"/>
              </a:ext>
            </a:extLst>
          </p:cNvPr>
          <p:cNvSpPr txBox="1"/>
          <p:nvPr/>
        </p:nvSpPr>
        <p:spPr>
          <a:xfrm>
            <a:off x="1463040" y="1675008"/>
            <a:ext cx="122301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/>
              <a:t>Sirt2+/+ </a:t>
            </a:r>
            <a:r>
              <a:rPr lang="en-US" sz="1200" dirty="0"/>
              <a:t>Mito fraction (n = 3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C828184-4EAB-4036-B24B-004923EB78FD}"/>
              </a:ext>
            </a:extLst>
          </p:cNvPr>
          <p:cNvSpPr txBox="1"/>
          <p:nvPr/>
        </p:nvSpPr>
        <p:spPr>
          <a:xfrm>
            <a:off x="2774669" y="1793118"/>
            <a:ext cx="2885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i="1" dirty="0"/>
              <a:t>+</a:t>
            </a:r>
            <a:endParaRPr lang="en-US" sz="1600" b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143D45D-C3EA-71D7-ADFF-7BB939225C2A}"/>
              </a:ext>
            </a:extLst>
          </p:cNvPr>
          <p:cNvSpPr txBox="1"/>
          <p:nvPr/>
        </p:nvSpPr>
        <p:spPr>
          <a:xfrm>
            <a:off x="3167099" y="1796928"/>
            <a:ext cx="38763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i="1" dirty="0"/>
              <a:t>−</a:t>
            </a:r>
          </a:p>
          <a:p>
            <a:endParaRPr lang="en-US" sz="1600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C3C47A4-3BE5-D99D-0D89-1F900498EB80}"/>
              </a:ext>
            </a:extLst>
          </p:cNvPr>
          <p:cNvSpPr txBox="1"/>
          <p:nvPr/>
        </p:nvSpPr>
        <p:spPr>
          <a:xfrm>
            <a:off x="790406" y="1185148"/>
            <a:ext cx="15859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nti-Sirt2</a:t>
            </a:r>
          </a:p>
        </p:txBody>
      </p:sp>
      <p:pic>
        <p:nvPicPr>
          <p:cNvPr id="10" name="Picture 9" descr="A picture containing text, white&#10;&#10;Description automatically generated">
            <a:extLst>
              <a:ext uri="{FF2B5EF4-FFF2-40B4-BE49-F238E27FC236}">
                <a16:creationId xmlns:a16="http://schemas.microsoft.com/office/drawing/2014/main" id="{D2182F44-620D-DA15-4578-F9680E44B57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92" t="1271" r="62646" b="50228"/>
          <a:stretch/>
        </p:blipFill>
        <p:spPr>
          <a:xfrm rot="16200000">
            <a:off x="6197793" y="63734"/>
            <a:ext cx="3677070" cy="6730532"/>
          </a:xfrm>
          <a:prstGeom prst="rect">
            <a:avLst/>
          </a:prstGeom>
        </p:spPr>
      </p:pic>
      <p:sp>
        <p:nvSpPr>
          <p:cNvPr id="11" name="Frame 10">
            <a:extLst>
              <a:ext uri="{FF2B5EF4-FFF2-40B4-BE49-F238E27FC236}">
                <a16:creationId xmlns:a16="http://schemas.microsoft.com/office/drawing/2014/main" id="{5826CB02-8054-DD42-9C4E-07037BC570EC}"/>
              </a:ext>
            </a:extLst>
          </p:cNvPr>
          <p:cNvSpPr/>
          <p:nvPr/>
        </p:nvSpPr>
        <p:spPr>
          <a:xfrm>
            <a:off x="5162551" y="3864864"/>
            <a:ext cx="2116073" cy="670560"/>
          </a:xfrm>
          <a:prstGeom prst="frame">
            <a:avLst>
              <a:gd name="adj1" fmla="val 1228"/>
            </a:avLst>
          </a:prstGeom>
          <a:ln>
            <a:solidFill>
              <a:srgbClr val="FF0000"/>
            </a:solidFill>
          </a:ln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09B00DB-E792-E9A6-2BFA-8C4A594E6F59}"/>
              </a:ext>
            </a:extLst>
          </p:cNvPr>
          <p:cNvSpPr txBox="1"/>
          <p:nvPr/>
        </p:nvSpPr>
        <p:spPr>
          <a:xfrm>
            <a:off x="4582442" y="5538968"/>
            <a:ext cx="31442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Mito fraction ponceau loading control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DCF53F0B-F5AC-1AA9-B8DB-10AF9A479E56}"/>
              </a:ext>
            </a:extLst>
          </p:cNvPr>
          <p:cNvSpPr/>
          <p:nvPr/>
        </p:nvSpPr>
        <p:spPr>
          <a:xfrm>
            <a:off x="1463040" y="3547872"/>
            <a:ext cx="2091690" cy="46166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6009468-DCA8-AAC6-F0A6-500F972108B8}"/>
              </a:ext>
            </a:extLst>
          </p:cNvPr>
          <p:cNvSpPr txBox="1"/>
          <p:nvPr/>
        </p:nvSpPr>
        <p:spPr>
          <a:xfrm>
            <a:off x="1810623" y="4157816"/>
            <a:ext cx="1131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2e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1AD0950-410D-EFB7-6534-3BAD306B8F9E}"/>
              </a:ext>
            </a:extLst>
          </p:cNvPr>
          <p:cNvSpPr txBox="1"/>
          <p:nvPr/>
        </p:nvSpPr>
        <p:spPr>
          <a:xfrm>
            <a:off x="5465519" y="4664388"/>
            <a:ext cx="1131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2e</a:t>
            </a:r>
          </a:p>
        </p:txBody>
      </p:sp>
    </p:spTree>
    <p:extLst>
      <p:ext uri="{BB962C8B-B14F-4D97-AF65-F5344CB8AC3E}">
        <p14:creationId xmlns:p14="http://schemas.microsoft.com/office/powerpoint/2010/main" val="16844432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 descr="A picture containing text, white&#10;&#10;Description automatically generated">
            <a:extLst>
              <a:ext uri="{FF2B5EF4-FFF2-40B4-BE49-F238E27FC236}">
                <a16:creationId xmlns:a16="http://schemas.microsoft.com/office/drawing/2014/main" id="{D2182F44-620D-DA15-4578-F9680E44B57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92" t="1271" r="62646" b="50228"/>
          <a:stretch/>
        </p:blipFill>
        <p:spPr>
          <a:xfrm rot="16200000">
            <a:off x="6197793" y="131352"/>
            <a:ext cx="3677070" cy="6730532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409B00DB-E792-E9A6-2BFA-8C4A594E6F59}"/>
              </a:ext>
            </a:extLst>
          </p:cNvPr>
          <p:cNvSpPr txBox="1"/>
          <p:nvPr/>
        </p:nvSpPr>
        <p:spPr>
          <a:xfrm>
            <a:off x="7531382" y="5538968"/>
            <a:ext cx="314423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Peroxisome fraction ponceau loading control</a:t>
            </a:r>
          </a:p>
        </p:txBody>
      </p:sp>
      <p:sp>
        <p:nvSpPr>
          <p:cNvPr id="13" name="Frame 12">
            <a:extLst>
              <a:ext uri="{FF2B5EF4-FFF2-40B4-BE49-F238E27FC236}">
                <a16:creationId xmlns:a16="http://schemas.microsoft.com/office/drawing/2014/main" id="{E60E28AB-F287-71AF-F8E9-C99FD5B0DEB9}"/>
              </a:ext>
            </a:extLst>
          </p:cNvPr>
          <p:cNvSpPr/>
          <p:nvPr/>
        </p:nvSpPr>
        <p:spPr>
          <a:xfrm>
            <a:off x="8205599" y="3669792"/>
            <a:ext cx="2116073" cy="670560"/>
          </a:xfrm>
          <a:prstGeom prst="frame">
            <a:avLst>
              <a:gd name="adj1" fmla="val 1228"/>
            </a:avLst>
          </a:prstGeom>
          <a:ln>
            <a:solidFill>
              <a:srgbClr val="FF0000"/>
            </a:solidFill>
          </a:ln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B9D8BA6-89E1-C094-0CEC-47013251F1AF}"/>
              </a:ext>
            </a:extLst>
          </p:cNvPr>
          <p:cNvSpPr txBox="1"/>
          <p:nvPr/>
        </p:nvSpPr>
        <p:spPr>
          <a:xfrm>
            <a:off x="8459051" y="4791776"/>
            <a:ext cx="10801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2f</a:t>
            </a:r>
          </a:p>
        </p:txBody>
      </p:sp>
    </p:spTree>
    <p:extLst>
      <p:ext uri="{BB962C8B-B14F-4D97-AF65-F5344CB8AC3E}">
        <p14:creationId xmlns:p14="http://schemas.microsoft.com/office/powerpoint/2010/main" val="330200037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picture containing white&#10;&#10;Description automatically generated">
            <a:extLst>
              <a:ext uri="{FF2B5EF4-FFF2-40B4-BE49-F238E27FC236}">
                <a16:creationId xmlns:a16="http://schemas.microsoft.com/office/drawing/2014/main" id="{1F148F2E-6805-88D4-3E4A-BC65072DFF7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189" t="32074" r="28241" b="15435"/>
          <a:stretch/>
        </p:blipFill>
        <p:spPr>
          <a:xfrm rot="21406729">
            <a:off x="1403814" y="763055"/>
            <a:ext cx="2242355" cy="208286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007571C0-26D3-8FBE-FD3F-E704C6F86D78}"/>
              </a:ext>
            </a:extLst>
          </p:cNvPr>
          <p:cNvSpPr txBox="1"/>
          <p:nvPr/>
        </p:nvSpPr>
        <p:spPr>
          <a:xfrm>
            <a:off x="1403814" y="578389"/>
            <a:ext cx="17222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ito Fraction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91AC66B-4D8E-8D19-F434-F13E23904E6D}"/>
              </a:ext>
            </a:extLst>
          </p:cNvPr>
          <p:cNvSpPr txBox="1"/>
          <p:nvPr/>
        </p:nvSpPr>
        <p:spPr>
          <a:xfrm>
            <a:off x="444339" y="1589043"/>
            <a:ext cx="1213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nti-ACOX1</a:t>
            </a:r>
          </a:p>
        </p:txBody>
      </p:sp>
      <p:pic>
        <p:nvPicPr>
          <p:cNvPr id="7" name="Picture 6" descr="A picture containing screenshot&#10;&#10;Description automatically generated">
            <a:extLst>
              <a:ext uri="{FF2B5EF4-FFF2-40B4-BE49-F238E27FC236}">
                <a16:creationId xmlns:a16="http://schemas.microsoft.com/office/drawing/2014/main" id="{5F05D59C-DE26-4B4A-0ED7-9CE5D93072A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838" t="33694" r="19754" b="31363"/>
          <a:stretch/>
        </p:blipFill>
        <p:spPr>
          <a:xfrm>
            <a:off x="2752554" y="3747808"/>
            <a:ext cx="3019596" cy="2115288"/>
          </a:xfrm>
          <a:prstGeom prst="rect">
            <a:avLst/>
          </a:prstGeom>
        </p:spPr>
      </p:pic>
      <p:pic>
        <p:nvPicPr>
          <p:cNvPr id="9" name="Picture 8" descr="A picture containing white&#10;&#10;Description automatically generated">
            <a:extLst>
              <a:ext uri="{FF2B5EF4-FFF2-40B4-BE49-F238E27FC236}">
                <a16:creationId xmlns:a16="http://schemas.microsoft.com/office/drawing/2014/main" id="{A36F10F3-A254-DC5D-217D-77C516E3BC67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544" t="31610" r="23749" b="17230"/>
          <a:stretch/>
        </p:blipFill>
        <p:spPr>
          <a:xfrm rot="195443">
            <a:off x="5772150" y="947721"/>
            <a:ext cx="2242355" cy="2021024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5AC41F92-9317-02B4-AD8D-F397BF0D3928}"/>
              </a:ext>
            </a:extLst>
          </p:cNvPr>
          <p:cNvSpPr txBox="1"/>
          <p:nvPr/>
        </p:nvSpPr>
        <p:spPr>
          <a:xfrm>
            <a:off x="5636765" y="578389"/>
            <a:ext cx="22423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eroxisome Fraction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02B3123-1F02-1393-9542-6763092D1DCB}"/>
              </a:ext>
            </a:extLst>
          </p:cNvPr>
          <p:cNvSpPr txBox="1"/>
          <p:nvPr/>
        </p:nvSpPr>
        <p:spPr>
          <a:xfrm>
            <a:off x="2914650" y="3593919"/>
            <a:ext cx="1213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nti-TIMM23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2EF3116-ABF2-62DF-44A5-A3CE4CEBB2CB}"/>
              </a:ext>
            </a:extLst>
          </p:cNvPr>
          <p:cNvSpPr txBox="1"/>
          <p:nvPr/>
        </p:nvSpPr>
        <p:spPr>
          <a:xfrm>
            <a:off x="1431979" y="4159789"/>
            <a:ext cx="17222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ito Fraction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EC1BA9B-90E0-95C6-81CA-23AC52F55ECB}"/>
              </a:ext>
            </a:extLst>
          </p:cNvPr>
          <p:cNvSpPr txBox="1"/>
          <p:nvPr/>
        </p:nvSpPr>
        <p:spPr>
          <a:xfrm>
            <a:off x="899856" y="5011442"/>
            <a:ext cx="22423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eroxisome Fraction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0D5E5B5-EB0E-0971-7C7D-BED8A594CC50}"/>
              </a:ext>
            </a:extLst>
          </p:cNvPr>
          <p:cNvSpPr txBox="1"/>
          <p:nvPr/>
        </p:nvSpPr>
        <p:spPr>
          <a:xfrm>
            <a:off x="2752554" y="5659524"/>
            <a:ext cx="36118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* Stripped, re-probed, and cut from original membranes (above). Exposed at the same time.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9F757E7-2155-CFE4-614A-69B4F409C5A3}"/>
              </a:ext>
            </a:extLst>
          </p:cNvPr>
          <p:cNvSpPr txBox="1"/>
          <p:nvPr/>
        </p:nvSpPr>
        <p:spPr>
          <a:xfrm>
            <a:off x="4682793" y="1770347"/>
            <a:ext cx="1213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nti-ACOX1</a:t>
            </a:r>
          </a:p>
        </p:txBody>
      </p:sp>
      <p:sp>
        <p:nvSpPr>
          <p:cNvPr id="2" name="Frame 1">
            <a:extLst>
              <a:ext uri="{FF2B5EF4-FFF2-40B4-BE49-F238E27FC236}">
                <a16:creationId xmlns:a16="http://schemas.microsoft.com/office/drawing/2014/main" id="{70143B54-4F33-5FA2-D70E-4A631CCDF2F7}"/>
              </a:ext>
            </a:extLst>
          </p:cNvPr>
          <p:cNvSpPr/>
          <p:nvPr/>
        </p:nvSpPr>
        <p:spPr>
          <a:xfrm>
            <a:off x="1737127" y="1625597"/>
            <a:ext cx="771357" cy="271223"/>
          </a:xfrm>
          <a:prstGeom prst="frame">
            <a:avLst>
              <a:gd name="adj1" fmla="val 1228"/>
            </a:avLst>
          </a:prstGeom>
          <a:ln>
            <a:solidFill>
              <a:srgbClr val="FF0000"/>
            </a:solidFill>
          </a:ln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8" name="Frame 7">
            <a:extLst>
              <a:ext uri="{FF2B5EF4-FFF2-40B4-BE49-F238E27FC236}">
                <a16:creationId xmlns:a16="http://schemas.microsoft.com/office/drawing/2014/main" id="{40914D9B-6535-A110-992E-6FA038BB69E3}"/>
              </a:ext>
            </a:extLst>
          </p:cNvPr>
          <p:cNvSpPr/>
          <p:nvPr/>
        </p:nvSpPr>
        <p:spPr>
          <a:xfrm>
            <a:off x="6211601" y="1718047"/>
            <a:ext cx="771357" cy="271223"/>
          </a:xfrm>
          <a:prstGeom prst="frame">
            <a:avLst>
              <a:gd name="adj1" fmla="val 1228"/>
            </a:avLst>
          </a:prstGeom>
          <a:ln>
            <a:solidFill>
              <a:srgbClr val="FF0000"/>
            </a:solidFill>
          </a:ln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2" name="Frame 11">
            <a:extLst>
              <a:ext uri="{FF2B5EF4-FFF2-40B4-BE49-F238E27FC236}">
                <a16:creationId xmlns:a16="http://schemas.microsoft.com/office/drawing/2014/main" id="{D7853CC0-F531-9E0D-45A4-A907C9DA9B6A}"/>
              </a:ext>
            </a:extLst>
          </p:cNvPr>
          <p:cNvSpPr/>
          <p:nvPr/>
        </p:nvSpPr>
        <p:spPr>
          <a:xfrm>
            <a:off x="3064711" y="4209633"/>
            <a:ext cx="946457" cy="307777"/>
          </a:xfrm>
          <a:prstGeom prst="frame">
            <a:avLst>
              <a:gd name="adj1" fmla="val 1228"/>
            </a:avLst>
          </a:prstGeom>
          <a:ln>
            <a:solidFill>
              <a:srgbClr val="FF0000"/>
            </a:solidFill>
          </a:ln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900276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5</TotalTime>
  <Words>231</Words>
  <Application>Microsoft Office PowerPoint</Application>
  <PresentationFormat>Widescreen</PresentationFormat>
  <Paragraphs>46</Paragraphs>
  <Slides>6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lexandra Schmidt</dc:creator>
  <cp:lastModifiedBy>Goetzman, Eric</cp:lastModifiedBy>
  <cp:revision>4</cp:revision>
  <dcterms:created xsi:type="dcterms:W3CDTF">2024-08-08T15:02:56Z</dcterms:created>
  <dcterms:modified xsi:type="dcterms:W3CDTF">2024-08-19T18:15:28Z</dcterms:modified>
</cp:coreProperties>
</file>